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61" r:id="rId2"/>
    <p:sldId id="273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48" autoAdjust="0"/>
    <p:restoredTop sz="94220" autoAdjust="0"/>
  </p:normalViewPr>
  <p:slideViewPr>
    <p:cSldViewPr snapToGrid="0">
      <p:cViewPr varScale="1">
        <p:scale>
          <a:sx n="104" d="100"/>
          <a:sy n="104" d="100"/>
        </p:scale>
        <p:origin x="6954" y="1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225766-C0FB-4FAD-AC56-C6577F1E0B5F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2EF1C2-FB5A-45B6-8E94-937912646E5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38428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093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062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95486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404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1106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7712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4400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9018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40753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0553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093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A0C97-E3EF-4038-B10F-AE37927DD02D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2F33A-1919-44D4-85FD-F1CEC272FC5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2451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AA57EC39-3ECD-4420-A256-895D06BD7370}"/>
              </a:ext>
            </a:extLst>
          </p:cNvPr>
          <p:cNvGrpSpPr/>
          <p:nvPr/>
        </p:nvGrpSpPr>
        <p:grpSpPr>
          <a:xfrm>
            <a:off x="170330" y="1136645"/>
            <a:ext cx="6385065" cy="5965602"/>
            <a:chOff x="313765" y="1629704"/>
            <a:chExt cx="6385065" cy="5965602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53EC1B4E-2665-4E4F-8895-3C0C394F7E09}"/>
                </a:ext>
              </a:extLst>
            </p:cNvPr>
            <p:cNvSpPr txBox="1"/>
            <p:nvPr/>
          </p:nvSpPr>
          <p:spPr>
            <a:xfrm>
              <a:off x="528093" y="1668176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62A992AD-25A6-4E0D-AB91-A55D2E507208}"/>
                </a:ext>
              </a:extLst>
            </p:cNvPr>
            <p:cNvSpPr txBox="1"/>
            <p:nvPr/>
          </p:nvSpPr>
          <p:spPr>
            <a:xfrm>
              <a:off x="3850619" y="1663686"/>
              <a:ext cx="2792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555B42C3-25C4-4978-B7CC-38601357AB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76"/>
            <a:stretch/>
          </p:blipFill>
          <p:spPr>
            <a:xfrm>
              <a:off x="313765" y="1977651"/>
              <a:ext cx="3032759" cy="2621279"/>
            </a:xfrm>
            <a:prstGeom prst="rect">
              <a:avLst/>
            </a:prstGeom>
          </p:spPr>
        </p:pic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2458C7B-C7E0-4F93-9768-69706EE9E18A}"/>
                </a:ext>
              </a:extLst>
            </p:cNvPr>
            <p:cNvSpPr txBox="1"/>
            <p:nvPr/>
          </p:nvSpPr>
          <p:spPr>
            <a:xfrm>
              <a:off x="1142387" y="1629704"/>
              <a:ext cx="16193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Profile 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8DA6E4BB-605F-451D-B432-EAFB5CA6A53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188"/>
            <a:stretch/>
          </p:blipFill>
          <p:spPr>
            <a:xfrm>
              <a:off x="3756212" y="2029026"/>
              <a:ext cx="2858794" cy="2569904"/>
            </a:xfrm>
            <a:prstGeom prst="rect">
              <a:avLst/>
            </a:prstGeom>
          </p:spPr>
        </p:pic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7510842F-3A73-4395-A1FF-6AF0ACB2AE45}"/>
                </a:ext>
              </a:extLst>
            </p:cNvPr>
            <p:cNvSpPr txBox="1"/>
            <p:nvPr/>
          </p:nvSpPr>
          <p:spPr>
            <a:xfrm>
              <a:off x="4452943" y="1663686"/>
              <a:ext cx="16193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Profile 8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4762C165-C8C3-4090-9067-D059F767549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23"/>
            <a:stretch/>
          </p:blipFill>
          <p:spPr>
            <a:xfrm>
              <a:off x="623046" y="4945921"/>
              <a:ext cx="2723478" cy="2649385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C40A052-13FC-4183-8927-4AD3E962DE5A}"/>
                </a:ext>
              </a:extLst>
            </p:cNvPr>
            <p:cNvSpPr txBox="1"/>
            <p:nvPr/>
          </p:nvSpPr>
          <p:spPr>
            <a:xfrm>
              <a:off x="623046" y="4645840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2F904091-5DFE-4FF5-BEC6-9160111CF5E5}"/>
                </a:ext>
              </a:extLst>
            </p:cNvPr>
            <p:cNvSpPr txBox="1"/>
            <p:nvPr/>
          </p:nvSpPr>
          <p:spPr>
            <a:xfrm>
              <a:off x="3945572" y="4641350"/>
              <a:ext cx="2792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04C75226-BE37-40AD-8D48-6B72A920B43D}"/>
                </a:ext>
              </a:extLst>
            </p:cNvPr>
            <p:cNvSpPr txBox="1"/>
            <p:nvPr/>
          </p:nvSpPr>
          <p:spPr>
            <a:xfrm>
              <a:off x="1098293" y="4609426"/>
              <a:ext cx="16770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Profile 13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1C48A26F-DA8E-4BAF-967D-2333C6C7CDF6}"/>
                </a:ext>
              </a:extLst>
            </p:cNvPr>
            <p:cNvSpPr txBox="1"/>
            <p:nvPr/>
          </p:nvSpPr>
          <p:spPr>
            <a:xfrm>
              <a:off x="4402687" y="4625716"/>
              <a:ext cx="173637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Profile 16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D98E2D28-C54A-468C-9007-BF4CA0C2761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593"/>
            <a:stretch/>
          </p:blipFill>
          <p:spPr>
            <a:xfrm>
              <a:off x="3656024" y="4953000"/>
              <a:ext cx="3042806" cy="262127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8288168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4EEFC68F-368B-4DDE-ABAC-B1655A3B42FB}"/>
              </a:ext>
            </a:extLst>
          </p:cNvPr>
          <p:cNvGrpSpPr/>
          <p:nvPr/>
        </p:nvGrpSpPr>
        <p:grpSpPr>
          <a:xfrm>
            <a:off x="478048" y="191429"/>
            <a:ext cx="6208502" cy="5956668"/>
            <a:chOff x="478048" y="191429"/>
            <a:chExt cx="6208502" cy="5956668"/>
          </a:xfrm>
        </p:grpSpPr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0639C6D2-4883-46AD-BDB5-72A8F40B27FD}"/>
                </a:ext>
              </a:extLst>
            </p:cNvPr>
            <p:cNvSpPr txBox="1"/>
            <p:nvPr/>
          </p:nvSpPr>
          <p:spPr>
            <a:xfrm>
              <a:off x="606003" y="229901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D637BE3-2D6C-476F-9A20-4B37B55247C1}"/>
                </a:ext>
              </a:extLst>
            </p:cNvPr>
            <p:cNvSpPr txBox="1"/>
            <p:nvPr/>
          </p:nvSpPr>
          <p:spPr>
            <a:xfrm>
              <a:off x="3928529" y="225411"/>
              <a:ext cx="27924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8C144EF5-5AA0-46AE-B0A8-1C009F9B45E2}"/>
                </a:ext>
              </a:extLst>
            </p:cNvPr>
            <p:cNvSpPr txBox="1"/>
            <p:nvPr/>
          </p:nvSpPr>
          <p:spPr>
            <a:xfrm>
              <a:off x="1191443" y="191429"/>
              <a:ext cx="16770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Profile 20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4817CEA7-7D92-49C1-8442-702CF5D95A23}"/>
                </a:ext>
              </a:extLst>
            </p:cNvPr>
            <p:cNvSpPr txBox="1"/>
            <p:nvPr/>
          </p:nvSpPr>
          <p:spPr>
            <a:xfrm>
              <a:off x="4501999" y="225411"/>
              <a:ext cx="16770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Profile 23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075CC4E7-2803-4F94-AD08-A748D998F886}"/>
                </a:ext>
              </a:extLst>
            </p:cNvPr>
            <p:cNvSpPr txBox="1"/>
            <p:nvPr/>
          </p:nvSpPr>
          <p:spPr>
            <a:xfrm>
              <a:off x="700956" y="3207565"/>
              <a:ext cx="29367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4F25CC2B-09CB-43C4-B3B9-B272C41EB2F8}"/>
                </a:ext>
              </a:extLst>
            </p:cNvPr>
            <p:cNvSpPr txBox="1"/>
            <p:nvPr/>
          </p:nvSpPr>
          <p:spPr>
            <a:xfrm>
              <a:off x="1176203" y="3171151"/>
              <a:ext cx="167706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Top 20 of KEGG enrichment of</a:t>
              </a:r>
            </a:p>
            <a:p>
              <a:pPr algn="ctr"/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up-regulated</a:t>
              </a:r>
              <a:r>
                <a:rPr lang="zh-CN" alt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DEGs of Profile 2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8C538B10-9EA4-4229-8856-49F27B0E31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97"/>
            <a:stretch/>
          </p:blipFill>
          <p:spPr>
            <a:xfrm>
              <a:off x="478048" y="521426"/>
              <a:ext cx="2950952" cy="2649725"/>
            </a:xfrm>
            <a:prstGeom prst="rect">
              <a:avLst/>
            </a:prstGeom>
          </p:spPr>
        </p:pic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682B4EF2-54BC-4546-A08E-CAEC444B94C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63"/>
            <a:stretch/>
          </p:blipFill>
          <p:spPr>
            <a:xfrm>
              <a:off x="3857624" y="544915"/>
              <a:ext cx="2828926" cy="2582439"/>
            </a:xfrm>
            <a:prstGeom prst="rect">
              <a:avLst/>
            </a:prstGeom>
          </p:spPr>
        </p:pic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3B6F5F11-8741-4E83-A032-73BECD01C64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445" b="-972"/>
            <a:stretch/>
          </p:blipFill>
          <p:spPr>
            <a:xfrm>
              <a:off x="700956" y="3546119"/>
              <a:ext cx="2695575" cy="2601978"/>
            </a:xfrm>
            <a:prstGeom prst="rect">
              <a:avLst/>
            </a:prstGeom>
          </p:spPr>
        </p:pic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A4C1E047-6115-47D2-A7AD-6637C9DB0E2B}"/>
              </a:ext>
            </a:extLst>
          </p:cNvPr>
          <p:cNvSpPr txBox="1"/>
          <p:nvPr/>
        </p:nvSpPr>
        <p:spPr>
          <a:xfrm>
            <a:off x="300234" y="6148097"/>
            <a:ext cx="638631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altLang="zh-CN" sz="1200" b="1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5. Kyoto Encyclopedia of Genes and Genomes (KEGG) database pathway enrichment of upregulated DEGs belonging to significant gene clusters.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top 20 enriched pathways are indicated for upregulated DEGs from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A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0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8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13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D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16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E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20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F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23, </a:t>
            </a: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(G)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luster 25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50241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69</TotalTime>
  <Words>168</Words>
  <Application>Microsoft Office PowerPoint</Application>
  <PresentationFormat>A4 纸张(210x297 毫米)</PresentationFormat>
  <Paragraphs>2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Tianyi</dc:creator>
  <cp:lastModifiedBy>Ma Tianyi</cp:lastModifiedBy>
  <cp:revision>135</cp:revision>
  <dcterms:created xsi:type="dcterms:W3CDTF">2021-01-19T12:49:28Z</dcterms:created>
  <dcterms:modified xsi:type="dcterms:W3CDTF">2023-01-10T11:16:25Z</dcterms:modified>
</cp:coreProperties>
</file>